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923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4754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0261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2540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0254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562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4072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1749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5927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345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49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3C63F-D6E8-4189-879D-519F08C59548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C70BC-C318-4134-8744-473D7CE5801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8930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252" y="0"/>
            <a:ext cx="8853495" cy="6858000"/>
          </a:xfrm>
          <a:prstGeom prst="rect">
            <a:avLst/>
          </a:prstGeom>
        </p:spPr>
      </p:pic>
      <p:cxnSp>
        <p:nvCxnSpPr>
          <p:cNvPr id="6" name="直接连接符 5"/>
          <p:cNvCxnSpPr/>
          <p:nvPr/>
        </p:nvCxnSpPr>
        <p:spPr>
          <a:xfrm>
            <a:off x="3596054" y="3481754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4988170" y="3493477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371493" y="3493477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7789985" y="3478823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692769" y="3050931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034328" y="3109491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527681" y="3115353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375888" y="3068516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58262" y="334108"/>
            <a:ext cx="89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KT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53190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252" y="0"/>
            <a:ext cx="8853495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89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-AKT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4018084" y="4870939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5410200" y="4882662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793523" y="4882662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8212015" y="4868008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4114799" y="4440116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456358" y="4498676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949711" y="4504538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797918" y="4457701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962701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252" y="0"/>
            <a:ext cx="8853495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89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ERK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3613635" y="4870939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5005751" y="4882662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389074" y="4882662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7807566" y="4868008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710350" y="4440116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051909" y="4498676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545262" y="4504538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393469" y="4457701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801031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252" y="0"/>
            <a:ext cx="8853495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89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-ERK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3270735" y="615462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4662851" y="627185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046174" y="627185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7464666" y="612531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367450" y="184639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709009" y="243199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202362" y="249061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050569" y="202224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412261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252" y="0"/>
            <a:ext cx="8853495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896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HP2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3499335" y="700509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4891451" y="712232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274774" y="712232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7693266" y="697578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596050" y="269686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937609" y="328246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430962" y="334108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279169" y="287271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26133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252" y="0"/>
            <a:ext cx="8853495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1131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-SHP2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3385035" y="2072109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4777151" y="2083832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160474" y="2083832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7578966" y="2069178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481750" y="1641286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823309" y="1699846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316662" y="1705708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164869" y="1658871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94253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9252" y="0"/>
            <a:ext cx="8853495" cy="6858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8262" y="334108"/>
            <a:ext cx="1131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APDH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>
            <a:off x="3560881" y="3540425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4952997" y="3552148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6336320" y="3552148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7754812" y="3537494"/>
            <a:ext cx="1248508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657596" y="3109602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vehicle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999155" y="3168162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492508" y="3174024"/>
            <a:ext cx="1890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>
                <a:solidFill>
                  <a:srgbClr val="FF0000"/>
                </a:solidFill>
              </a:rPr>
              <a:t>SHP099+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340715" y="3127187"/>
            <a:ext cx="10638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solidFill>
                  <a:srgbClr val="FF0000"/>
                </a:solidFill>
              </a:rPr>
              <a:t>DrugB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14" name="直接箭头连接符 13"/>
          <p:cNvCxnSpPr/>
          <p:nvPr/>
        </p:nvCxnSpPr>
        <p:spPr>
          <a:xfrm flipV="1">
            <a:off x="3270738" y="4862148"/>
            <a:ext cx="202224" cy="21980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2646484" y="5081954"/>
            <a:ext cx="14507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Other experiment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76171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7</Words>
  <Application>Microsoft Office PowerPoint</Application>
  <PresentationFormat>宽屏</PresentationFormat>
  <Paragraphs>36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袁云仓</dc:creator>
  <cp:lastModifiedBy>袁云仓</cp:lastModifiedBy>
  <cp:revision>1</cp:revision>
  <dcterms:created xsi:type="dcterms:W3CDTF">2021-07-20T02:12:49Z</dcterms:created>
  <dcterms:modified xsi:type="dcterms:W3CDTF">2021-07-20T02:21:51Z</dcterms:modified>
</cp:coreProperties>
</file>